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6" r:id="rId2"/>
    <p:sldId id="284" r:id="rId3"/>
    <p:sldId id="287" r:id="rId4"/>
  </p:sldIdLst>
  <p:sldSz cx="6858000" cy="9144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55" autoAdjust="0"/>
    <p:restoredTop sz="97059" autoAdjust="0"/>
  </p:normalViewPr>
  <p:slideViewPr>
    <p:cSldViewPr>
      <p:cViewPr varScale="1">
        <p:scale>
          <a:sx n="78" d="100"/>
          <a:sy n="78" d="100"/>
        </p:scale>
        <p:origin x="444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330" cy="7633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8831" cy="493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4" y="0"/>
            <a:ext cx="2918831" cy="493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16B933-2B79-4A45-9954-AA1BB092D7C1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6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8008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374301"/>
            <a:ext cx="2918831" cy="493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4" y="9374301"/>
            <a:ext cx="2918831" cy="493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1109E3-F7A0-4F61-A4A0-E0AE2034B2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08368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266B36-6733-4D48-8A41-9DF9750E0875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5891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8363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177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799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3381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21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7642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424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1691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441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9079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7208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8B8D13-3A4F-4869-A8E2-90674EB53C3A}" type="datetimeFigureOut">
              <a:rPr kumimoji="1" lang="ja-JP" altLang="en-US" smtClean="0"/>
              <a:t>2025/12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0CBD0F-5452-4CBD-BBD1-2647DC4C5A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200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B2AD588A-A45A-4B83-B902-F6A144AE9E53}"/>
              </a:ext>
            </a:extLst>
          </p:cNvPr>
          <p:cNvCxnSpPr>
            <a:cxnSpLocks/>
          </p:cNvCxnSpPr>
          <p:nvPr/>
        </p:nvCxnSpPr>
        <p:spPr>
          <a:xfrm>
            <a:off x="2447856" y="1772452"/>
            <a:ext cx="0" cy="99229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A03EFD11-B8BF-4D28-80E0-DF8B471E79B7}"/>
              </a:ext>
            </a:extLst>
          </p:cNvPr>
          <p:cNvSpPr/>
          <p:nvPr/>
        </p:nvSpPr>
        <p:spPr>
          <a:xfrm>
            <a:off x="2540531" y="2038583"/>
            <a:ext cx="2262407" cy="68697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</a:rPr>
              <a:t>IHC screening for TRK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386633BE-B6A8-44C9-A6E6-4D1FEB1C660B}"/>
              </a:ext>
            </a:extLst>
          </p:cNvPr>
          <p:cNvSpPr/>
          <p:nvPr/>
        </p:nvSpPr>
        <p:spPr>
          <a:xfrm>
            <a:off x="1780350" y="1046293"/>
            <a:ext cx="2700000" cy="972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dirty="0">
                <a:solidFill>
                  <a:schemeClr val="tx1"/>
                </a:solidFill>
              </a:rPr>
              <a:t>Study cases</a:t>
            </a:r>
          </a:p>
          <a:p>
            <a:r>
              <a:rPr lang="en-US" altLang="ja-JP" dirty="0">
                <a:solidFill>
                  <a:schemeClr val="tx1"/>
                </a:solidFill>
              </a:rPr>
              <a:t> ESCC n=254</a:t>
            </a:r>
          </a:p>
          <a:p>
            <a:r>
              <a:rPr kumimoji="1" lang="en-US" altLang="ja-JP" dirty="0">
                <a:solidFill>
                  <a:schemeClr val="tx1"/>
                </a:solidFill>
              </a:rPr>
              <a:t> G</a:t>
            </a:r>
            <a:r>
              <a:rPr lang="en-US" altLang="ja-JP" dirty="0">
                <a:solidFill>
                  <a:schemeClr val="tx1"/>
                </a:solidFill>
              </a:rPr>
              <a:t>C n=401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E20E3D82-58E1-420E-B437-E0DF9D36CF28}"/>
              </a:ext>
            </a:extLst>
          </p:cNvPr>
          <p:cNvCxnSpPr/>
          <p:nvPr/>
        </p:nvCxnSpPr>
        <p:spPr>
          <a:xfrm>
            <a:off x="2447856" y="3488853"/>
            <a:ext cx="0" cy="99229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DE811C8A-EA2B-4D60-A824-1ADA36272E42}"/>
              </a:ext>
            </a:extLst>
          </p:cNvPr>
          <p:cNvSpPr/>
          <p:nvPr/>
        </p:nvSpPr>
        <p:spPr>
          <a:xfrm>
            <a:off x="2341079" y="3794173"/>
            <a:ext cx="3683141" cy="68697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</a:rPr>
              <a:t>NGS/FISH analysis for </a:t>
            </a:r>
            <a:r>
              <a:rPr lang="en-US" altLang="ja-JP" i="1" dirty="0">
                <a:solidFill>
                  <a:schemeClr val="tx1"/>
                </a:solidFill>
              </a:rPr>
              <a:t>NTRK</a:t>
            </a:r>
            <a:r>
              <a:rPr lang="en-US" altLang="ja-JP" dirty="0">
                <a:solidFill>
                  <a:schemeClr val="tx1"/>
                </a:solidFill>
              </a:rPr>
              <a:t> fusions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53281A0C-0D8A-4B04-93B1-760639201726}"/>
              </a:ext>
            </a:extLst>
          </p:cNvPr>
          <p:cNvSpPr/>
          <p:nvPr/>
        </p:nvSpPr>
        <p:spPr>
          <a:xfrm>
            <a:off x="1780351" y="2770982"/>
            <a:ext cx="2700000" cy="972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dirty="0">
                <a:solidFill>
                  <a:schemeClr val="tx1"/>
                </a:solidFill>
              </a:rPr>
              <a:t>Positive TRK expression</a:t>
            </a:r>
          </a:p>
          <a:p>
            <a:r>
              <a:rPr lang="en-US" altLang="ja-JP" dirty="0">
                <a:solidFill>
                  <a:schemeClr val="tx1"/>
                </a:solidFill>
              </a:rPr>
              <a:t> ESCC n=10</a:t>
            </a:r>
          </a:p>
          <a:p>
            <a:r>
              <a:rPr kumimoji="1" lang="en-US" altLang="ja-JP" dirty="0">
                <a:solidFill>
                  <a:schemeClr val="tx1"/>
                </a:solidFill>
              </a:rPr>
              <a:t> G</a:t>
            </a:r>
            <a:r>
              <a:rPr lang="en-US" altLang="ja-JP" dirty="0">
                <a:solidFill>
                  <a:schemeClr val="tx1"/>
                </a:solidFill>
              </a:rPr>
              <a:t>C n=0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E6576E4A-E6F3-4190-9326-65E8BAEC6228}"/>
              </a:ext>
            </a:extLst>
          </p:cNvPr>
          <p:cNvSpPr/>
          <p:nvPr/>
        </p:nvSpPr>
        <p:spPr>
          <a:xfrm>
            <a:off x="1780350" y="4495670"/>
            <a:ext cx="2736000" cy="68697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i="1" dirty="0">
                <a:solidFill>
                  <a:schemeClr val="tx1"/>
                </a:solidFill>
              </a:rPr>
              <a:t>NTRK</a:t>
            </a:r>
            <a:r>
              <a:rPr lang="en-US" altLang="ja-JP" dirty="0">
                <a:solidFill>
                  <a:schemeClr val="tx1"/>
                </a:solidFill>
              </a:rPr>
              <a:t> fusions positive cases</a:t>
            </a:r>
          </a:p>
          <a:p>
            <a:r>
              <a:rPr lang="en-US" altLang="ja-JP" dirty="0">
                <a:solidFill>
                  <a:schemeClr val="tx1"/>
                </a:solidFill>
              </a:rPr>
              <a:t> ESCC n=0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510CF5C-8C02-8FD4-DD7F-73594FD6EF8D}"/>
              </a:ext>
            </a:extLst>
          </p:cNvPr>
          <p:cNvSpPr txBox="1"/>
          <p:nvPr/>
        </p:nvSpPr>
        <p:spPr>
          <a:xfrm>
            <a:off x="5849067" y="22119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1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D7348A4-DD09-5120-A40B-45C3CA90F182}"/>
              </a:ext>
            </a:extLst>
          </p:cNvPr>
          <p:cNvSpPr txBox="1"/>
          <p:nvPr/>
        </p:nvSpPr>
        <p:spPr>
          <a:xfrm>
            <a:off x="440882" y="5346390"/>
            <a:ext cx="604131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Fig. S1. Flowchart summarizing the study design and numbers at each step. Esophageal squamous cell carcinoma (ESCC), Gastric adenocarcinoma (GA),</a:t>
            </a:r>
            <a:r>
              <a:rPr lang="en-US" altLang="ja-JP" sz="1400" dirty="0"/>
              <a:t> </a:t>
            </a:r>
            <a:r>
              <a:rPr kumimoji="1" lang="en-US" altLang="ja-JP" sz="1400" dirty="0"/>
              <a:t>Immunohistochemical staining (IHC), fluorescence in situ hybridization (FISH).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2467734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 descr="夜空に光っている星の絵&#10;&#10;AI 生成コンテンツは誤りを含む可能性があります。">
            <a:extLst>
              <a:ext uri="{FF2B5EF4-FFF2-40B4-BE49-F238E27FC236}">
                <a16:creationId xmlns:a16="http://schemas.microsoft.com/office/drawing/2014/main" id="{6673477D-F107-38CB-CEF6-25AE49768AD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800" y="755500"/>
            <a:ext cx="6106400" cy="4342329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4B628DA-5D8A-1DFF-EF81-A1BD6EE99542}"/>
              </a:ext>
            </a:extLst>
          </p:cNvPr>
          <p:cNvSpPr txBox="1"/>
          <p:nvPr/>
        </p:nvSpPr>
        <p:spPr>
          <a:xfrm>
            <a:off x="5849067" y="22119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2</a:t>
            </a:r>
            <a:endParaRPr kumimoji="1"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E12D6DD-A097-1817-0AB9-9C6EEEEB2162}"/>
              </a:ext>
            </a:extLst>
          </p:cNvPr>
          <p:cNvSpPr txBox="1"/>
          <p:nvPr/>
        </p:nvSpPr>
        <p:spPr>
          <a:xfrm>
            <a:off x="440882" y="5193730"/>
            <a:ext cx="60413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Fig. S2. </a:t>
            </a:r>
            <a:r>
              <a:rPr kumimoji="1" lang="en-US" altLang="ja-JP" sz="1400" i="1" dirty="0"/>
              <a:t>NTRK1</a:t>
            </a:r>
            <a:r>
              <a:rPr kumimoji="1" lang="en-US" altLang="ja-JP" sz="1400" dirty="0"/>
              <a:t> FISH in esophageal cancer. Representative images from a case showing FISH for </a:t>
            </a:r>
            <a:r>
              <a:rPr kumimoji="1" lang="en-US" altLang="ja-JP" sz="1400" i="1" dirty="0"/>
              <a:t>NTRK1</a:t>
            </a:r>
            <a:r>
              <a:rPr kumimoji="1" lang="en-US" altLang="ja-JP" sz="1400" dirty="0"/>
              <a:t> fusion.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279910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9415DDA7-2C7B-A87C-FCAB-DB7BCE2BC1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7683301"/>
              </p:ext>
            </p:extLst>
          </p:nvPr>
        </p:nvGraphicFramePr>
        <p:xfrm>
          <a:off x="342900" y="908160"/>
          <a:ext cx="6172200" cy="4435378"/>
        </p:xfrm>
        <a:graphic>
          <a:graphicData uri="http://schemas.openxmlformats.org/drawingml/2006/table">
            <a:tbl>
              <a:tblPr/>
              <a:tblGrid>
                <a:gridCol w="625377">
                  <a:extLst>
                    <a:ext uri="{9D8B030D-6E8A-4147-A177-3AD203B41FA5}">
                      <a16:colId xmlns:a16="http://schemas.microsoft.com/office/drawing/2014/main" val="2106754980"/>
                    </a:ext>
                  </a:extLst>
                </a:gridCol>
                <a:gridCol w="679758">
                  <a:extLst>
                    <a:ext uri="{9D8B030D-6E8A-4147-A177-3AD203B41FA5}">
                      <a16:colId xmlns:a16="http://schemas.microsoft.com/office/drawing/2014/main" val="1422470132"/>
                    </a:ext>
                  </a:extLst>
                </a:gridCol>
                <a:gridCol w="396978">
                  <a:extLst>
                    <a:ext uri="{9D8B030D-6E8A-4147-A177-3AD203B41FA5}">
                      <a16:colId xmlns:a16="http://schemas.microsoft.com/office/drawing/2014/main" val="1527536956"/>
                    </a:ext>
                  </a:extLst>
                </a:gridCol>
                <a:gridCol w="511178">
                  <a:extLst>
                    <a:ext uri="{9D8B030D-6E8A-4147-A177-3AD203B41FA5}">
                      <a16:colId xmlns:a16="http://schemas.microsoft.com/office/drawing/2014/main" val="1516866389"/>
                    </a:ext>
                  </a:extLst>
                </a:gridCol>
                <a:gridCol w="391540">
                  <a:extLst>
                    <a:ext uri="{9D8B030D-6E8A-4147-A177-3AD203B41FA5}">
                      <a16:colId xmlns:a16="http://schemas.microsoft.com/office/drawing/2014/main" val="189636287"/>
                    </a:ext>
                  </a:extLst>
                </a:gridCol>
                <a:gridCol w="391540">
                  <a:extLst>
                    <a:ext uri="{9D8B030D-6E8A-4147-A177-3AD203B41FA5}">
                      <a16:colId xmlns:a16="http://schemas.microsoft.com/office/drawing/2014/main" val="2467669230"/>
                    </a:ext>
                  </a:extLst>
                </a:gridCol>
                <a:gridCol w="560121">
                  <a:extLst>
                    <a:ext uri="{9D8B030D-6E8A-4147-A177-3AD203B41FA5}">
                      <a16:colId xmlns:a16="http://schemas.microsoft.com/office/drawing/2014/main" val="3919090621"/>
                    </a:ext>
                  </a:extLst>
                </a:gridCol>
                <a:gridCol w="732326">
                  <a:extLst>
                    <a:ext uri="{9D8B030D-6E8A-4147-A177-3AD203B41FA5}">
                      <a16:colId xmlns:a16="http://schemas.microsoft.com/office/drawing/2014/main" val="114743636"/>
                    </a:ext>
                  </a:extLst>
                </a:gridCol>
                <a:gridCol w="942597">
                  <a:extLst>
                    <a:ext uri="{9D8B030D-6E8A-4147-A177-3AD203B41FA5}">
                      <a16:colId xmlns:a16="http://schemas.microsoft.com/office/drawing/2014/main" val="1073674794"/>
                    </a:ext>
                  </a:extLst>
                </a:gridCol>
                <a:gridCol w="940785">
                  <a:extLst>
                    <a:ext uri="{9D8B030D-6E8A-4147-A177-3AD203B41FA5}">
                      <a16:colId xmlns:a16="http://schemas.microsoft.com/office/drawing/2014/main" val="1998181862"/>
                    </a:ext>
                  </a:extLst>
                </a:gridCol>
              </a:tblGrid>
              <a:tr h="164648">
                <a:tc gridSpan="10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upplementary Table S1. Next generation sequencing result in esophageal squamous cell carcinom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36958760"/>
                  </a:ext>
                </a:extLst>
              </a:tr>
              <a:tr h="164648"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number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utations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opy number alterations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52216651"/>
                  </a:ext>
                </a:extLst>
              </a:tr>
              <a:tr h="2292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ene Symbol</a:t>
                      </a:r>
                    </a:p>
                  </a:txBody>
                  <a:tcPr marL="6333" marR="6333" marT="633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hr</a:t>
                      </a:r>
                    </a:p>
                  </a:txBody>
                  <a:tcPr marL="6333" marR="6333" marT="633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osition</a:t>
                      </a:r>
                    </a:p>
                  </a:txBody>
                  <a:tcPr marL="6333" marR="6333" marT="633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f</a:t>
                      </a:r>
                    </a:p>
                  </a:txBody>
                  <a:tcPr marL="6333" marR="6333" marT="633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lt</a:t>
                      </a:r>
                    </a:p>
                  </a:txBody>
                  <a:tcPr marL="6333" marR="6333" marT="633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GVS.p </a:t>
                      </a:r>
                    </a:p>
                  </a:txBody>
                  <a:tcPr marL="6333" marR="6333" marT="633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33" marR="6333" marT="6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mplifications</a:t>
                      </a:r>
                    </a:p>
                  </a:txBody>
                  <a:tcPr marL="6333" marR="6333" marT="633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omozygous deletions</a:t>
                      </a:r>
                    </a:p>
                  </a:txBody>
                  <a:tcPr marL="6333" marR="6333" marT="633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1399926"/>
                  </a:ext>
                </a:extLst>
              </a:tr>
              <a:tr h="229241">
                <a:tc row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FE2L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8098808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C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78_E79insE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9212590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KN2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1971111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83Y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8889311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ALB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6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3647379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163fs*4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0541032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8290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Splicing)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4272153"/>
                  </a:ext>
                </a:extLst>
              </a:tr>
              <a:tr h="158316"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8234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Y205*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GFR1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KN2A, RB1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1107533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844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Y163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7065383"/>
                  </a:ext>
                </a:extLst>
              </a:tr>
              <a:tr h="158316">
                <a:tc row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FE2L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8098806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80K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9775690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B1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895538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Splicing)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900808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7518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255F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016299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8240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204fs*5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2556483"/>
                  </a:ext>
                </a:extLst>
              </a:tr>
              <a:tr h="158316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TCH1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941229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450*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HL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2478721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844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Y163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0330880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OTCH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5290241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Q1132*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1889557"/>
                  </a:ext>
                </a:extLst>
              </a:tr>
              <a:tr h="158316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IK3C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8952085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047L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Y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HL, RHOA, RAD51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1323507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7556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242Y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8036302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KDM6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X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4970655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*1402S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2961182"/>
                  </a:ext>
                </a:extLst>
              </a:tr>
              <a:tr h="158316"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CH1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824233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329fs*108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6372192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8265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195N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4435872"/>
                  </a:ext>
                </a:extLst>
              </a:tr>
              <a:tr h="158316">
                <a:tc row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IK3C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893608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542K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HOA, FLT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1232418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8406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175H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65192791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8454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159V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2317711"/>
                  </a:ext>
                </a:extLst>
              </a:tr>
              <a:tr h="15831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P300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156648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Q1455R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4861539"/>
                  </a:ext>
                </a:extLst>
              </a:tr>
              <a:tr h="158316">
                <a:tc rowSpan="2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FE2L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809880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80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6908892"/>
                  </a:ext>
                </a:extLst>
              </a:tr>
              <a:tr h="16464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P53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579521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56*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ja-JP" altLang="en-US" sz="7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33" marR="6333" marT="63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59317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80929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42</TotalTime>
  <Words>331</Words>
  <Application>Microsoft Office PowerPoint</Application>
  <PresentationFormat>画面に合わせる (4:3)</PresentationFormat>
  <Paragraphs>190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​​テーマ</vt:lpstr>
      <vt:lpstr>PowerPoint プレゼンテーション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nobu Saito</dc:creator>
  <cp:lastModifiedBy>Motonobu Saito</cp:lastModifiedBy>
  <cp:revision>591</cp:revision>
  <cp:lastPrinted>2020-12-08T04:56:52Z</cp:lastPrinted>
  <dcterms:created xsi:type="dcterms:W3CDTF">2017-06-02T06:16:10Z</dcterms:created>
  <dcterms:modified xsi:type="dcterms:W3CDTF">2025-12-10T00:50:01Z</dcterms:modified>
</cp:coreProperties>
</file>